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9" r:id="rId4"/>
    <p:sldId id="258" r:id="rId5"/>
    <p:sldId id="257" r:id="rId6"/>
    <p:sldId id="261" r:id="rId7"/>
    <p:sldId id="262" r:id="rId8"/>
    <p:sldId id="268" r:id="rId9"/>
    <p:sldId id="263" r:id="rId10"/>
    <p:sldId id="264" r:id="rId11"/>
    <p:sldId id="265" r:id="rId12"/>
    <p:sldId id="266" r:id="rId13"/>
    <p:sldId id="267" r:id="rId14"/>
  </p:sldIdLst>
  <p:sldSz cx="6858000" cy="9144000" type="screen4x3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8" autoAdjust="0"/>
    <p:restoredTop sz="94660"/>
  </p:normalViewPr>
  <p:slideViewPr>
    <p:cSldViewPr>
      <p:cViewPr varScale="1">
        <p:scale>
          <a:sx n="59" d="100"/>
          <a:sy n="59" d="100"/>
        </p:scale>
        <p:origin x="2510" y="77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6.11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3" Type="http://schemas.openxmlformats.org/officeDocument/2006/relationships/image" Target="../media/image21.png"/><Relationship Id="rId7" Type="http://schemas.openxmlformats.org/officeDocument/2006/relationships/image" Target="../media/image25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8393177"/>
              </p:ext>
            </p:extLst>
          </p:nvPr>
        </p:nvGraphicFramePr>
        <p:xfrm>
          <a:off x="764704" y="971600"/>
          <a:ext cx="5395098" cy="607107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79208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401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4589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77501">
                <a:tc gridSpan="3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Oligonucleotides (Eurofins)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80617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Luci </a:t>
                      </a: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shRNA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op: 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5’-AACCCC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GCTGAGTACTTCGAAATGTC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TCAAGAGA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GACATTTCGAAGTACTCAGCG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TTTTTC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Bottom: 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5’-TCGAGAAAAAA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GCTGAGTACTTCGAAATGTC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TCTCTTGAA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GACATTTCGAAGTACTCAGCG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GGGGTT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80617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BCL-XL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shRNA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op: 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5’-AACCCC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GGAGATGCAGGTATTGGTG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TCAAGAGA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ACCAATACCTGCATCTCC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TTTTTC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Bottom: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5’-TCGAGAAAAAA</a:t>
                      </a:r>
                      <a:r>
                        <a:rPr lang="en-US" sz="900" u="sng" cap="all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GGAGATGCAGGTATTGGTG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TCTCTTGAA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ACCAATACCTGCATCTCC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GGGGTT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80617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BIM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shRNA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op: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5’-AACCCC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GATGTAAGTTCTGAGTGTG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TCAAGAGA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ACACTCAGAACTTACATCA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TTTTTC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Bottom: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 marL="0" indent="0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5’-TCGAGAAAAAA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GATGTAAGTTCTGAGTGTG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TCTCTTGAA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ACACTCAGAACTTACATCA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GGGGTT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5374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BCL-2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PCR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Forward (</a:t>
                      </a:r>
                      <a:r>
                        <a:rPr lang="en-US" sz="900" dirty="0" err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EcoRI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):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5’-CCGGAATTCACC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ATGGCGCACGCTGGGAGAACA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Reverse (</a:t>
                      </a:r>
                      <a:r>
                        <a:rPr lang="en-US" sz="900" dirty="0" err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NotI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):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5’-ATTTGCGGCCGCTTTA</a:t>
                      </a:r>
                      <a:r>
                        <a:rPr lang="en-US" sz="900" u="sng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TCACTTGTGGCCCAGATAGGCA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3314">
                <a:tc gridSpan="3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 err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qRT</a:t>
                      </a: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PCR  Human Primers (Eurofins/ </a:t>
                      </a:r>
                      <a:r>
                        <a:rPr lang="en-US" sz="900" b="1" dirty="0" err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Apara</a:t>
                      </a: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)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6872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18S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Forward: 5’-TCAAGAACGAAAGTCGGAGG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Reverse: 5’-GGACATCTAAGGGCATCACA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26872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36B4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Forward: 5’-CAGCAAGTGGGAAGGTGTAATCC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Reverse: 5’-CCCATTCTATCATCAACGGGTACAA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6872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BCL-XL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Forward: 5’-TTCTCCTTCGGCGGGGCACT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Reverse: 5’-CGGCTCTCGGCTGCTGCATT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63314">
                <a:tc gridSpan="3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Sequencing Primers (Eurofins)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26872"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pLeGOhU6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pPr marL="0" indent="0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>
                  <a:txBody>
                    <a:bodyPr/>
                    <a:lstStyle/>
                    <a:p>
                      <a:pPr marL="0" indent="0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Forward: 5’-ATATATCTTGTGGAAAGGACG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 marL="0" indent="0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Reverse: 5’-TGGCCCAACGTTAGCTATTTTCAT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26872"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 err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pLeGO-iG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Forward: 5’-CCCTGCGCCTTATTTGAATTAACC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Reverse: 5’-GCTTCGGCCAGTAACGTTAGG-3’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1289" marR="61289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5" name="Rechteck 4"/>
          <p:cNvSpPr/>
          <p:nvPr/>
        </p:nvSpPr>
        <p:spPr>
          <a:xfrm>
            <a:off x="692696" y="603995"/>
            <a:ext cx="424847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tabLst>
                <a:tab pos="628650" algn="l"/>
              </a:tabLst>
            </a:pP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Table 1: Oligonucleotides and Primers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89856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56" name="Picture 1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0728" y="239713"/>
            <a:ext cx="4660506" cy="76386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Rechteck 48"/>
          <p:cNvSpPr/>
          <p:nvPr/>
        </p:nvSpPr>
        <p:spPr>
          <a:xfrm>
            <a:off x="476672" y="8030706"/>
            <a:ext cx="5832648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8: BCL-2 overexpression rescues BCL-XL deficient erythroid progenitors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Human CD34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HSPC were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lentivirally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transduced as indicated. Data show %untransduced, %GFP and/or tomato cells from various erythroid populations at days 4 and 12 of HEMA culture. Bars represent mean ± SEM, n=4 from 4 independent experiments.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714485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332656" y="7668344"/>
            <a:ext cx="633670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9: BIM knockdown does not rescue BCL-XL deficient erythroid cells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Human CD34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HSPC were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lentivirally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transduced with one or two viruses as indicated. Cells were cultured under HEMA conditions and analyzed after 4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A, C)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(left bars) and 12 days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B, D)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of culture. n=2, two mixed cord blood CD34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derived cells from 1 independent experiment. In addition,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BCL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XL-Tomato cells with BIM knockdown were cultured in the presence of 10-fold concentrations of EPO and/or SCF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E, F)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.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0784" y="306814"/>
            <a:ext cx="4640362" cy="706581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476283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395536"/>
            <a:ext cx="4392488" cy="65739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hteck 3"/>
          <p:cNvSpPr/>
          <p:nvPr/>
        </p:nvSpPr>
        <p:spPr>
          <a:xfrm>
            <a:off x="311721" y="7164288"/>
            <a:ext cx="6192688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10: BIM knockdown does not aid in engraftment of BCL-XL deficient human HSPC during xenotransplantation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Human CD34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HSPC were either left untransduced or were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lentivirally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transduced in the following 4 groups: untransduced (Control); pLeGOhU6 with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Luc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and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dTomato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+ pLeGOhU6 with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Luc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and GFP (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Luc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T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Luc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G); pLeGOhU6 with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BCL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XL and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dTomato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+ pLeGOhU6 with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Luc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and GFP (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BCL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XL-T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Luc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G); pLeGOhU6 with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BCL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XL and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dTomato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+ pLeGOhU6 with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BIM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and GFP (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BCL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XL-T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hBIM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G). The cells were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i.v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injected in </a:t>
            </a:r>
            <a:r>
              <a:rPr lang="en-US" sz="1000" i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ag2</a:t>
            </a:r>
            <a:r>
              <a:rPr lang="en-US" sz="1000" i="1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−/−</a:t>
            </a:r>
            <a:r>
              <a:rPr lang="en-US" sz="1000" i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γc</a:t>
            </a:r>
            <a:r>
              <a:rPr lang="en-US" sz="1000" i="1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−/−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mice after sub-lethal irradiation. Mice were sacrificed 6 weeks after transplantation and bone marrow (BM) and spleen were analyzed for the presence of human CD45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cells via flow cytometry. Bars represent mean ± SEM, n=4 from 3 independent experiments.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759577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720" y="1481748"/>
            <a:ext cx="5067300" cy="287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hteck 3"/>
          <p:cNvSpPr/>
          <p:nvPr/>
        </p:nvSpPr>
        <p:spPr>
          <a:xfrm>
            <a:off x="620688" y="5078378"/>
            <a:ext cx="5688632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11: PUMA and BNIP3L/NIX are highly expressed in human erythroid cells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Un-manipulated CD34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cells were cultured in HEMA for 12 days and mRNA was isolated for RT-MLPA. Expression levels of the indicated proteins are compared to those obtained with freshly isolated CD34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cells. Bars represent mean ± SEM, n=4 from 4 independent experiments.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38376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el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7018887"/>
              </p:ext>
            </p:extLst>
          </p:nvPr>
        </p:nvGraphicFramePr>
        <p:xfrm>
          <a:off x="620688" y="1010178"/>
          <a:ext cx="5328592" cy="213741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9596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0874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6024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5557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Population</a:t>
                      </a:r>
                      <a:endParaRPr lang="de-DE" sz="10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Abbreviation</a:t>
                      </a:r>
                      <a:endParaRPr lang="de-DE" sz="10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haracterization</a:t>
                      </a:r>
                      <a:endParaRPr lang="de-DE" sz="10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1310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Hematopoietic Stem Cells</a:t>
                      </a:r>
                      <a:endParaRPr lang="de-DE" sz="1000" b="1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HSC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34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38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45RA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90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3083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Multipotent Progenitors</a:t>
                      </a:r>
                      <a:endParaRPr lang="de-DE" sz="1000" b="1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MPP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34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38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45RA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90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1310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olony Forming Unit Granulocytes</a:t>
                      </a:r>
                      <a:endParaRPr lang="de-DE" sz="1000" b="1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FU-G 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34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33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15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115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3083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Granulocytic Monocytic precursors</a:t>
                      </a:r>
                      <a:endParaRPr lang="de-DE" sz="1000" b="1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GM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34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33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115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1310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Monocytes/Macrophage precursors</a:t>
                      </a:r>
                      <a:endParaRPr lang="de-DE" sz="1000" b="1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M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34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 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33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14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115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Immature erythroid cells</a:t>
                      </a:r>
                      <a:endParaRPr lang="de-DE" sz="1000" b="1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endParaRPr lang="de-DE" sz="10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71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high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235a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endParaRPr lang="de-DE" sz="10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573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Mature erythroid cells</a:t>
                      </a:r>
                      <a:endParaRPr lang="de-DE" sz="10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endParaRPr lang="de-DE" sz="10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71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235a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endParaRPr lang="de-DE" sz="10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8" name="Rechteck 7"/>
          <p:cNvSpPr/>
          <p:nvPr/>
        </p:nvSpPr>
        <p:spPr>
          <a:xfrm>
            <a:off x="548680" y="631305"/>
            <a:ext cx="489654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Table 2: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MethoCult</a:t>
            </a:r>
            <a:r>
              <a:rPr lang="en-US" sz="1000" b="1" baseline="30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TM</a:t>
            </a:r>
            <a:r>
              <a:rPr lang="en-US" sz="1000" b="1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population definitions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graphicFrame>
        <p:nvGraphicFramePr>
          <p:cNvPr id="9" name="Tabel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1044685"/>
              </p:ext>
            </p:extLst>
          </p:nvPr>
        </p:nvGraphicFramePr>
        <p:xfrm>
          <a:off x="620688" y="4674459"/>
          <a:ext cx="4896544" cy="2020697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0937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0282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1145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Population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haracterization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9390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Non-Erythroid (Non-</a:t>
                      </a:r>
                      <a:r>
                        <a:rPr lang="en-US" sz="900" b="1" dirty="0" err="1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Es</a:t>
                      </a: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)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71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235a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endParaRPr lang="de-DE" sz="9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145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Early BFU/CFU-e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117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71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med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235a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 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   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(Abbreviation:</a:t>
                      </a:r>
                      <a:r>
                        <a:rPr lang="en-US" sz="900" baseline="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med=medium)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145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Late BFU/CFU-e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117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71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high</a:t>
                      </a:r>
                      <a:r>
                        <a:rPr lang="en-US" sz="9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235a</a:t>
                      </a:r>
                      <a:r>
                        <a:rPr lang="en-US" sz="900" baseline="3000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endParaRPr lang="de-DE" sz="9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10845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Basophilic erythroblasts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117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71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high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235a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9390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Polychromatophilic/orthochromatic erythroblasts/ reticulocytes (or mature erythroblasts)</a:t>
                      </a:r>
                      <a:endParaRPr lang="de-DE" sz="900" b="1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D117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-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71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 CD235a</a:t>
                      </a:r>
                      <a:r>
                        <a:rPr lang="en-US" sz="900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+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 </a:t>
                      </a:r>
                      <a:endParaRPr lang="de-DE" sz="9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0" name="Rechteck 9"/>
          <p:cNvSpPr/>
          <p:nvPr/>
        </p:nvSpPr>
        <p:spPr>
          <a:xfrm>
            <a:off x="548680" y="4325779"/>
            <a:ext cx="410445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Table 3: HEMA population definitions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36149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404664" y="6662554"/>
            <a:ext cx="5688632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1: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EK293T cells were transfected with plasmids expressing Luci shRNA or BCL-XL shRNA and GFP+ cells were sorted for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qRT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PCR. Gene expression was normalized to 18S. Bars represent mean ± SEM; n=4 from 4 independent experiments; p=0.0286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A)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. In addition, GFP+ HEK293T cells were used for Western blotting to demonstrate BCL-XL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downreguation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on protein level (B).</a:t>
            </a: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158" b="12808"/>
          <a:stretch/>
        </p:blipFill>
        <p:spPr bwMode="auto">
          <a:xfrm>
            <a:off x="462168" y="467544"/>
            <a:ext cx="4798127" cy="48584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0766081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3" t="3700" b="8965"/>
          <a:stretch/>
        </p:blipFill>
        <p:spPr bwMode="auto">
          <a:xfrm>
            <a:off x="1061467" y="474778"/>
            <a:ext cx="1411751" cy="13351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50" t="3839" r="-3303" b="7762"/>
          <a:stretch/>
        </p:blipFill>
        <p:spPr bwMode="auto">
          <a:xfrm>
            <a:off x="3079507" y="491540"/>
            <a:ext cx="1429613" cy="13513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66" t="2643" r="-1540" b="8029"/>
          <a:stretch/>
        </p:blipFill>
        <p:spPr bwMode="auto">
          <a:xfrm>
            <a:off x="4974704" y="491540"/>
            <a:ext cx="1406624" cy="13656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36" b="7618"/>
          <a:stretch/>
        </p:blipFill>
        <p:spPr bwMode="auto">
          <a:xfrm>
            <a:off x="1052737" y="2411760"/>
            <a:ext cx="1430898" cy="14122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24" t="3770" b="7340"/>
          <a:stretch/>
        </p:blipFill>
        <p:spPr bwMode="auto">
          <a:xfrm>
            <a:off x="3061508" y="2465158"/>
            <a:ext cx="1375604" cy="13588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90" t="3811" b="7618"/>
          <a:stretch/>
        </p:blipFill>
        <p:spPr bwMode="auto">
          <a:xfrm>
            <a:off x="1077825" y="4586560"/>
            <a:ext cx="1409400" cy="13540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9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50" t="3651" b="7142"/>
          <a:stretch/>
        </p:blipFill>
        <p:spPr bwMode="auto">
          <a:xfrm>
            <a:off x="3058803" y="4572451"/>
            <a:ext cx="1378309" cy="1363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10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02" t="3542" b="6933"/>
          <a:stretch/>
        </p:blipFill>
        <p:spPr bwMode="auto">
          <a:xfrm>
            <a:off x="4930266" y="4572000"/>
            <a:ext cx="1379054" cy="13686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11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02" t="2997" b="7797"/>
          <a:stretch/>
        </p:blipFill>
        <p:spPr bwMode="auto">
          <a:xfrm>
            <a:off x="3058058" y="6660232"/>
            <a:ext cx="1379054" cy="13637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12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32" t="2314" b="8890"/>
          <a:stretch/>
        </p:blipFill>
        <p:spPr bwMode="auto">
          <a:xfrm>
            <a:off x="4916754" y="6666475"/>
            <a:ext cx="1392566" cy="13575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4" name="Gerade Verbindung mit Pfeil 13"/>
          <p:cNvCxnSpPr/>
          <p:nvPr/>
        </p:nvCxnSpPr>
        <p:spPr>
          <a:xfrm>
            <a:off x="1340768" y="1929190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>
            <a:off x="3356992" y="1929190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>
            <a:off x="5229200" y="1929190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/>
          <p:nvPr/>
        </p:nvCxnSpPr>
        <p:spPr>
          <a:xfrm>
            <a:off x="1340768" y="3896062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>
            <a:off x="3326879" y="3896062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Gerade Verbindung mit Pfeil 18"/>
          <p:cNvCxnSpPr/>
          <p:nvPr/>
        </p:nvCxnSpPr>
        <p:spPr>
          <a:xfrm>
            <a:off x="3335543" y="8095989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>
            <a:off x="5267671" y="8095989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>
            <a:off x="1340768" y="6012611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>
            <a:off x="3324175" y="6012611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/>
          <p:nvPr/>
        </p:nvCxnSpPr>
        <p:spPr>
          <a:xfrm>
            <a:off x="5184762" y="6012611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rot="16200000" flipV="1">
            <a:off x="512677" y="1101098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rot="16200000" flipV="1">
            <a:off x="2528900" y="1101098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rot="16200000" flipV="1">
            <a:off x="4401108" y="1101098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rot="16200000" flipV="1">
            <a:off x="512677" y="3067970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 rot="16200000" flipV="1">
            <a:off x="2498787" y="3067970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/>
          <p:nvPr/>
        </p:nvCxnSpPr>
        <p:spPr>
          <a:xfrm rot="16200000" flipV="1">
            <a:off x="512677" y="5256527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/>
          <p:nvPr/>
        </p:nvCxnSpPr>
        <p:spPr>
          <a:xfrm rot="16200000" flipV="1">
            <a:off x="2496084" y="5256527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Gerade Verbindung mit Pfeil 30"/>
          <p:cNvCxnSpPr/>
          <p:nvPr/>
        </p:nvCxnSpPr>
        <p:spPr>
          <a:xfrm rot="16200000" flipV="1">
            <a:off x="4356670" y="5256527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Gerade Verbindung mit Pfeil 31"/>
          <p:cNvCxnSpPr/>
          <p:nvPr/>
        </p:nvCxnSpPr>
        <p:spPr>
          <a:xfrm rot="16200000" flipV="1">
            <a:off x="2507451" y="7339904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Gerade Verbindung mit Pfeil 32"/>
          <p:cNvCxnSpPr/>
          <p:nvPr/>
        </p:nvCxnSpPr>
        <p:spPr>
          <a:xfrm rot="16200000" flipV="1">
            <a:off x="4367571" y="7339905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1052737" y="1929190"/>
            <a:ext cx="5256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FSC                            CD38                       CD90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1052736" y="3896062"/>
            <a:ext cx="5256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FSC                         CD235a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1052736" y="6012611"/>
            <a:ext cx="5256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FSC                           CD33                          FSC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1052736" y="8095989"/>
            <a:ext cx="5256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CD115                        FSC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548680" y="588521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548680" y="2599918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548680" y="4780924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4437112" y="4780924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115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4437112" y="6864302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15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2564904" y="625495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4437112" y="481479"/>
            <a:ext cx="430887" cy="130369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45RA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2564904" y="2592367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71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2564904" y="4780924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2564904" y="6871853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548680" y="139442"/>
            <a:ext cx="3902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548680" y="2195736"/>
            <a:ext cx="3902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548680" y="4243898"/>
            <a:ext cx="3902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Gerade Verbindung mit Pfeil 50"/>
          <p:cNvCxnSpPr/>
          <p:nvPr/>
        </p:nvCxnSpPr>
        <p:spPr>
          <a:xfrm>
            <a:off x="2132856" y="1281118"/>
            <a:ext cx="50405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2" name="Gerade Verbindung mit Pfeil 51"/>
          <p:cNvCxnSpPr/>
          <p:nvPr/>
        </p:nvCxnSpPr>
        <p:spPr>
          <a:xfrm>
            <a:off x="3645024" y="921078"/>
            <a:ext cx="86409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3" name="Gerade Verbindung mit Pfeil 52"/>
          <p:cNvCxnSpPr/>
          <p:nvPr/>
        </p:nvCxnSpPr>
        <p:spPr>
          <a:xfrm>
            <a:off x="2132856" y="3247990"/>
            <a:ext cx="50405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4" name="Gerade Verbindung mit Pfeil 53"/>
          <p:cNvCxnSpPr/>
          <p:nvPr/>
        </p:nvCxnSpPr>
        <p:spPr>
          <a:xfrm>
            <a:off x="2132856" y="5364539"/>
            <a:ext cx="50405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5" name="Gerade Verbindung mit Pfeil 54"/>
          <p:cNvCxnSpPr/>
          <p:nvPr/>
        </p:nvCxnSpPr>
        <p:spPr>
          <a:xfrm>
            <a:off x="4005064" y="5220523"/>
            <a:ext cx="50405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6" name="Gerade Verbindung mit Pfeil 55"/>
          <p:cNvCxnSpPr/>
          <p:nvPr/>
        </p:nvCxnSpPr>
        <p:spPr>
          <a:xfrm>
            <a:off x="4374301" y="5689486"/>
            <a:ext cx="0" cy="93610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7" name="Gerade Verbindung mit Pfeil 56"/>
          <p:cNvCxnSpPr/>
          <p:nvPr/>
        </p:nvCxnSpPr>
        <p:spPr>
          <a:xfrm>
            <a:off x="3501008" y="7519925"/>
            <a:ext cx="100811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85" name="Rechteck 84"/>
          <p:cNvSpPr/>
          <p:nvPr/>
        </p:nvSpPr>
        <p:spPr>
          <a:xfrm>
            <a:off x="270788" y="8434543"/>
            <a:ext cx="632656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2: FACS gating strategy for various cell populations isolated after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MethoCult</a:t>
            </a:r>
            <a:r>
              <a:rPr lang="en-US" sz="1000" b="1" baseline="30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TM</a:t>
            </a:r>
            <a:r>
              <a:rPr lang="en-US" sz="1000" b="1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ulture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FACS plots show the gating strategy for CD34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cells, HSC and MPP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A)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, erythroid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B)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and myeloid cells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C)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. 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68638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512890" y="6220633"/>
            <a:ext cx="579643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3: Colony forming assays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. Human HSPC were seeded in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MethoCult</a:t>
            </a:r>
            <a:r>
              <a:rPr lang="en-US" sz="1000" baseline="30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TM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medium and cultured for 10 days. After culture, several hematopoietic populations were analyzed by flow cytometry; Granulocytic-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monocytic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precursors (GM), monocyte precursors (M), hematopoietic stem cells (HSC), multipotent progenitors (MPP), colony forming unit granulocytes (CFU-G) and CD71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igh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D235a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/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erythroid cells. Bars represent mean ± SEM, n=8-9 from 5 independent experiments.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653" y="1108066"/>
            <a:ext cx="6162675" cy="4705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8459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10" t="1662" r="-1283" b="13893"/>
          <a:stretch/>
        </p:blipFill>
        <p:spPr bwMode="auto">
          <a:xfrm>
            <a:off x="908720" y="1933313"/>
            <a:ext cx="1436844" cy="12531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18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74" t="2346" r="-1654" b="8130"/>
          <a:stretch/>
        </p:blipFill>
        <p:spPr bwMode="auto">
          <a:xfrm>
            <a:off x="2857105" y="1933313"/>
            <a:ext cx="1363983" cy="13284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7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22" t="2738" b="6896"/>
          <a:stretch/>
        </p:blipFill>
        <p:spPr bwMode="auto">
          <a:xfrm>
            <a:off x="984896" y="3842060"/>
            <a:ext cx="1363983" cy="13409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47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33" t="2163" r="-1479" b="4564"/>
          <a:stretch/>
        </p:blipFill>
        <p:spPr bwMode="auto">
          <a:xfrm>
            <a:off x="4722296" y="1933313"/>
            <a:ext cx="1371000" cy="13840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5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04" b="7172"/>
          <a:stretch/>
        </p:blipFill>
        <p:spPr bwMode="auto">
          <a:xfrm>
            <a:off x="2852936" y="3805521"/>
            <a:ext cx="1343125" cy="13775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" name="Gerade Verbindung mit Pfeil 8"/>
          <p:cNvCxnSpPr/>
          <p:nvPr/>
        </p:nvCxnSpPr>
        <p:spPr>
          <a:xfrm>
            <a:off x="1412776" y="3373473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feld 9"/>
          <p:cNvSpPr txBox="1"/>
          <p:nvPr/>
        </p:nvSpPr>
        <p:spPr>
          <a:xfrm>
            <a:off x="908720" y="3373473"/>
            <a:ext cx="52565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FSC                         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SC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CD235a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866454" y="5255048"/>
            <a:ext cx="36008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CD235a                   </a:t>
            </a:r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D235a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Gerade Verbindung mit Pfeil 11"/>
          <p:cNvCxnSpPr/>
          <p:nvPr/>
        </p:nvCxnSpPr>
        <p:spPr>
          <a:xfrm rot="16200000">
            <a:off x="368661" y="2617389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Gerade Verbindung mit Pfeil 12"/>
          <p:cNvCxnSpPr/>
          <p:nvPr/>
        </p:nvCxnSpPr>
        <p:spPr>
          <a:xfrm rot="16200000">
            <a:off x="2312876" y="2617389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rot="16200000">
            <a:off x="4185084" y="2617390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Gerade Verbindung mit Pfeil 14"/>
          <p:cNvCxnSpPr/>
          <p:nvPr/>
        </p:nvCxnSpPr>
        <p:spPr>
          <a:xfrm rot="16200000">
            <a:off x="440668" y="4570972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 rot="16200000">
            <a:off x="2312876" y="4570971"/>
            <a:ext cx="93610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feld 16"/>
          <p:cNvSpPr txBox="1"/>
          <p:nvPr/>
        </p:nvSpPr>
        <p:spPr>
          <a:xfrm>
            <a:off x="404664" y="2149337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2348880" y="2149337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117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4221088" y="2149337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71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476672" y="4063431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71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2350041" y="4063431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71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Gerade Verbindung mit Pfeil 21"/>
          <p:cNvCxnSpPr/>
          <p:nvPr/>
        </p:nvCxnSpPr>
        <p:spPr>
          <a:xfrm>
            <a:off x="1988840" y="3013433"/>
            <a:ext cx="50405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/>
          <p:nvPr/>
        </p:nvCxnSpPr>
        <p:spPr>
          <a:xfrm>
            <a:off x="3861048" y="2221345"/>
            <a:ext cx="504056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>
            <a:off x="1340768" y="3125511"/>
            <a:ext cx="0" cy="68001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>
            <a:off x="3284984" y="3341535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>
            <a:off x="5085184" y="3373473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>
            <a:off x="1412776" y="5255048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/>
          <p:nvPr/>
        </p:nvCxnSpPr>
        <p:spPr>
          <a:xfrm>
            <a:off x="3284984" y="5255048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feld 71"/>
          <p:cNvSpPr txBox="1"/>
          <p:nvPr/>
        </p:nvSpPr>
        <p:spPr>
          <a:xfrm>
            <a:off x="548680" y="1645281"/>
            <a:ext cx="3902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Gerade Verbindung 75"/>
          <p:cNvCxnSpPr/>
          <p:nvPr/>
        </p:nvCxnSpPr>
        <p:spPr>
          <a:xfrm flipH="1" flipV="1">
            <a:off x="5660615" y="2653393"/>
            <a:ext cx="633" cy="72008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Gerade Verbindung 83"/>
          <p:cNvCxnSpPr/>
          <p:nvPr/>
        </p:nvCxnSpPr>
        <p:spPr>
          <a:xfrm flipV="1">
            <a:off x="5829705" y="2005321"/>
            <a:ext cx="0" cy="72008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Gerade Verbindung 91"/>
          <p:cNvCxnSpPr/>
          <p:nvPr/>
        </p:nvCxnSpPr>
        <p:spPr>
          <a:xfrm flipV="1">
            <a:off x="5129687" y="2005321"/>
            <a:ext cx="0" cy="72008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Rechteck 92"/>
          <p:cNvSpPr/>
          <p:nvPr/>
        </p:nvSpPr>
        <p:spPr>
          <a:xfrm>
            <a:off x="65472" y="6178242"/>
            <a:ext cx="6747904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4: Human erythropoiesis and expression of cell surface markers. </a:t>
            </a:r>
          </a:p>
          <a:p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A)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ACS plots show gating strategy for various immature and mature erythroid populations based on expression of CD117, CD71 and CD235a in HEMA.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97" name="Gerade Verbindung mit Pfeil 96"/>
          <p:cNvCxnSpPr/>
          <p:nvPr/>
        </p:nvCxnSpPr>
        <p:spPr>
          <a:xfrm>
            <a:off x="3140968" y="3085441"/>
            <a:ext cx="0" cy="68001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708599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769" y="307429"/>
            <a:ext cx="6124575" cy="7000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hteck 3"/>
          <p:cNvSpPr/>
          <p:nvPr/>
        </p:nvSpPr>
        <p:spPr>
          <a:xfrm>
            <a:off x="548680" y="7452320"/>
            <a:ext cx="590465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5: Erythroid populations in HEMA culture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Lentivirally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transduced or untransduced human CD34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cells were cultured in Human Erythroid Massive Amplification assay (HEMA) to study impact of BCL-XL knockdown on erythroid differentiation </a:t>
            </a:r>
            <a:r>
              <a:rPr lang="en-US" sz="1000" i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in vitro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. Different populations were analyzed via flow cytometry at indicated time points of culture. Bars represent mean ± SEM, n=5 from 5 independent experiments. Statistical significance was determined by Mann Whitney test.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B)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*P= 0.0317.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73758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48" y="983794"/>
            <a:ext cx="5715000" cy="4781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hteck 3"/>
          <p:cNvSpPr/>
          <p:nvPr/>
        </p:nvSpPr>
        <p:spPr>
          <a:xfrm>
            <a:off x="116632" y="6240378"/>
            <a:ext cx="662473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6: BCL-XL is required for megakaryocyte survival.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-D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) Human HSPC were seeded in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MegaCult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medium and cultured for 12 days. CD61+ CD41+ megakaryocyte populations were analyzed by flow cytometry. Overall megakaryocyte populations (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, C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) and % GFP+ (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B, D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) are shown. Bars represent mean ± SEM, n=4 from 4 independent experiments. 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95579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48" t="2400" b="8801"/>
          <a:stretch/>
        </p:blipFill>
        <p:spPr bwMode="auto">
          <a:xfrm>
            <a:off x="980728" y="291721"/>
            <a:ext cx="1499187" cy="1413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51" t="2401" b="6401"/>
          <a:stretch/>
        </p:blipFill>
        <p:spPr bwMode="auto">
          <a:xfrm>
            <a:off x="2960308" y="318654"/>
            <a:ext cx="1463824" cy="14512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19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50" t="2400" b="8800"/>
          <a:stretch/>
        </p:blipFill>
        <p:spPr bwMode="auto">
          <a:xfrm>
            <a:off x="2973288" y="2267744"/>
            <a:ext cx="1463824" cy="1413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20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50" t="2400" b="8801"/>
          <a:stretch/>
        </p:blipFill>
        <p:spPr bwMode="auto">
          <a:xfrm>
            <a:off x="4869160" y="323528"/>
            <a:ext cx="1463824" cy="14130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" name="Gerade Verbindung mit Pfeil 82">
            <a:extLst>
              <a:ext uri="{FF2B5EF4-FFF2-40B4-BE49-F238E27FC236}">
                <a16:creationId xmlns:a16="http://schemas.microsoft.com/office/drawing/2014/main" id="{B0BCEE06-21F3-4367-8CCE-94521289C5B9}"/>
              </a:ext>
            </a:extLst>
          </p:cNvPr>
          <p:cNvCxnSpPr/>
          <p:nvPr/>
        </p:nvCxnSpPr>
        <p:spPr>
          <a:xfrm>
            <a:off x="3356992" y="3779912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Gerade Verbindung mit Pfeil 82">
            <a:extLst>
              <a:ext uri="{FF2B5EF4-FFF2-40B4-BE49-F238E27FC236}">
                <a16:creationId xmlns:a16="http://schemas.microsoft.com/office/drawing/2014/main" id="{4CA23F88-9CAF-4108-B7F2-3B2C5F6F0954}"/>
              </a:ext>
            </a:extLst>
          </p:cNvPr>
          <p:cNvCxnSpPr/>
          <p:nvPr/>
        </p:nvCxnSpPr>
        <p:spPr>
          <a:xfrm>
            <a:off x="3356992" y="1835696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Gerade Verbindung mit Pfeil 82">
            <a:extLst>
              <a:ext uri="{FF2B5EF4-FFF2-40B4-BE49-F238E27FC236}">
                <a16:creationId xmlns:a16="http://schemas.microsoft.com/office/drawing/2014/main" id="{8E82F40D-2F2D-40F4-92FE-47B790B0D0C3}"/>
              </a:ext>
            </a:extLst>
          </p:cNvPr>
          <p:cNvCxnSpPr/>
          <p:nvPr/>
        </p:nvCxnSpPr>
        <p:spPr>
          <a:xfrm>
            <a:off x="5373216" y="1835696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Gerade Verbindung mit Pfeil 82">
            <a:extLst>
              <a:ext uri="{FF2B5EF4-FFF2-40B4-BE49-F238E27FC236}">
                <a16:creationId xmlns:a16="http://schemas.microsoft.com/office/drawing/2014/main" id="{C830A24F-3C97-412F-9DD9-723CCE96D938}"/>
              </a:ext>
            </a:extLst>
          </p:cNvPr>
          <p:cNvCxnSpPr/>
          <p:nvPr/>
        </p:nvCxnSpPr>
        <p:spPr>
          <a:xfrm>
            <a:off x="1484784" y="1835696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Gerade Verbindung mit Pfeil 82">
            <a:extLst>
              <a:ext uri="{FF2B5EF4-FFF2-40B4-BE49-F238E27FC236}">
                <a16:creationId xmlns:a16="http://schemas.microsoft.com/office/drawing/2014/main" id="{49030D2C-0BCD-4BB4-A65A-0C4F37B2A22A}"/>
              </a:ext>
            </a:extLst>
          </p:cNvPr>
          <p:cNvCxnSpPr>
            <a:cxnSpLocks/>
          </p:cNvCxnSpPr>
          <p:nvPr/>
        </p:nvCxnSpPr>
        <p:spPr>
          <a:xfrm rot="16200000">
            <a:off x="548680" y="971601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Gerade Verbindung mit Pfeil 82">
            <a:extLst>
              <a:ext uri="{FF2B5EF4-FFF2-40B4-BE49-F238E27FC236}">
                <a16:creationId xmlns:a16="http://schemas.microsoft.com/office/drawing/2014/main" id="{A4C63403-885E-4430-87DD-E8EF99F663B7}"/>
              </a:ext>
            </a:extLst>
          </p:cNvPr>
          <p:cNvCxnSpPr>
            <a:cxnSpLocks/>
          </p:cNvCxnSpPr>
          <p:nvPr/>
        </p:nvCxnSpPr>
        <p:spPr>
          <a:xfrm rot="16200000">
            <a:off x="2564904" y="971601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Gerade Verbindung mit Pfeil 82">
            <a:extLst>
              <a:ext uri="{FF2B5EF4-FFF2-40B4-BE49-F238E27FC236}">
                <a16:creationId xmlns:a16="http://schemas.microsoft.com/office/drawing/2014/main" id="{8FA00C99-F8A6-499A-BF30-377E89EA735A}"/>
              </a:ext>
            </a:extLst>
          </p:cNvPr>
          <p:cNvCxnSpPr>
            <a:cxnSpLocks/>
          </p:cNvCxnSpPr>
          <p:nvPr/>
        </p:nvCxnSpPr>
        <p:spPr>
          <a:xfrm rot="16200000">
            <a:off x="4509120" y="971601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Gerade Verbindung mit Pfeil 82">
            <a:extLst>
              <a:ext uri="{FF2B5EF4-FFF2-40B4-BE49-F238E27FC236}">
                <a16:creationId xmlns:a16="http://schemas.microsoft.com/office/drawing/2014/main" id="{D7A7FF90-BD44-4C1A-8374-307BBF95B7FF}"/>
              </a:ext>
            </a:extLst>
          </p:cNvPr>
          <p:cNvCxnSpPr>
            <a:cxnSpLocks/>
          </p:cNvCxnSpPr>
          <p:nvPr/>
        </p:nvCxnSpPr>
        <p:spPr>
          <a:xfrm rot="16200000">
            <a:off x="2564904" y="3059833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feld 60">
            <a:extLst>
              <a:ext uri="{FF2B5EF4-FFF2-40B4-BE49-F238E27FC236}">
                <a16:creationId xmlns:a16="http://schemas.microsoft.com/office/drawing/2014/main" id="{C57B02E3-3054-41C3-8407-21269AC0382E}"/>
              </a:ext>
            </a:extLst>
          </p:cNvPr>
          <p:cNvSpPr txBox="1"/>
          <p:nvPr/>
        </p:nvSpPr>
        <p:spPr>
          <a:xfrm>
            <a:off x="1029072" y="1835696"/>
            <a:ext cx="5352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FSC                       muCD45                        FSC</a:t>
            </a:r>
          </a:p>
        </p:txBody>
      </p:sp>
      <p:sp>
        <p:nvSpPr>
          <p:cNvPr id="17" name="Textfeld 61">
            <a:extLst>
              <a:ext uri="{FF2B5EF4-FFF2-40B4-BE49-F238E27FC236}">
                <a16:creationId xmlns:a16="http://schemas.microsoft.com/office/drawing/2014/main" id="{815EE84F-9EE0-4F52-9DC4-954252376CBB}"/>
              </a:ext>
            </a:extLst>
          </p:cNvPr>
          <p:cNvSpPr txBox="1"/>
          <p:nvPr/>
        </p:nvSpPr>
        <p:spPr>
          <a:xfrm>
            <a:off x="2780473" y="3779912"/>
            <a:ext cx="165663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FSC             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67">
            <a:extLst>
              <a:ext uri="{FF2B5EF4-FFF2-40B4-BE49-F238E27FC236}">
                <a16:creationId xmlns:a16="http://schemas.microsoft.com/office/drawing/2014/main" id="{5706CFA1-2163-40DF-9309-65D0CA07B303}"/>
              </a:ext>
            </a:extLst>
          </p:cNvPr>
          <p:cNvSpPr txBox="1"/>
          <p:nvPr/>
        </p:nvSpPr>
        <p:spPr>
          <a:xfrm>
            <a:off x="476672" y="467544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67">
            <a:extLst>
              <a:ext uri="{FF2B5EF4-FFF2-40B4-BE49-F238E27FC236}">
                <a16:creationId xmlns:a16="http://schemas.microsoft.com/office/drawing/2014/main" id="{6E5DAD8D-106A-4578-BA02-F4555360C39B}"/>
              </a:ext>
            </a:extLst>
          </p:cNvPr>
          <p:cNvSpPr txBox="1"/>
          <p:nvPr/>
        </p:nvSpPr>
        <p:spPr>
          <a:xfrm>
            <a:off x="2492896" y="323528"/>
            <a:ext cx="430887" cy="12636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huCD45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67">
            <a:extLst>
              <a:ext uri="{FF2B5EF4-FFF2-40B4-BE49-F238E27FC236}">
                <a16:creationId xmlns:a16="http://schemas.microsoft.com/office/drawing/2014/main" id="{877F490C-EC9A-4D45-88B4-F5C0621E974D}"/>
              </a:ext>
            </a:extLst>
          </p:cNvPr>
          <p:cNvSpPr txBox="1"/>
          <p:nvPr/>
        </p:nvSpPr>
        <p:spPr>
          <a:xfrm>
            <a:off x="4437112" y="395536"/>
            <a:ext cx="430887" cy="12636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33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67">
            <a:extLst>
              <a:ext uri="{FF2B5EF4-FFF2-40B4-BE49-F238E27FC236}">
                <a16:creationId xmlns:a16="http://schemas.microsoft.com/office/drawing/2014/main" id="{812D365D-688C-42E9-93CB-2CC80A9BA730}"/>
              </a:ext>
            </a:extLst>
          </p:cNvPr>
          <p:cNvSpPr txBox="1"/>
          <p:nvPr/>
        </p:nvSpPr>
        <p:spPr>
          <a:xfrm>
            <a:off x="2492896" y="2444265"/>
            <a:ext cx="430887" cy="12636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2">
            <a:extLst>
              <a:ext uri="{FF2B5EF4-FFF2-40B4-BE49-F238E27FC236}">
                <a16:creationId xmlns:a16="http://schemas.microsoft.com/office/drawing/2014/main" id="{DBF82283-D832-4558-B05F-26092749A9C1}"/>
              </a:ext>
            </a:extLst>
          </p:cNvPr>
          <p:cNvSpPr txBox="1"/>
          <p:nvPr/>
        </p:nvSpPr>
        <p:spPr>
          <a:xfrm>
            <a:off x="446475" y="35496"/>
            <a:ext cx="3902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Gerade Verbindung mit Pfeil 72">
            <a:extLst>
              <a:ext uri="{FF2B5EF4-FFF2-40B4-BE49-F238E27FC236}">
                <a16:creationId xmlns:a16="http://schemas.microsoft.com/office/drawing/2014/main" id="{F6C53D1C-F478-4B42-88EE-3C62B1D4845A}"/>
              </a:ext>
            </a:extLst>
          </p:cNvPr>
          <p:cNvCxnSpPr>
            <a:cxnSpLocks/>
          </p:cNvCxnSpPr>
          <p:nvPr/>
        </p:nvCxnSpPr>
        <p:spPr>
          <a:xfrm>
            <a:off x="1988840" y="1259632"/>
            <a:ext cx="64807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4" name="Gerade Verbindung mit Pfeil 72">
            <a:extLst>
              <a:ext uri="{FF2B5EF4-FFF2-40B4-BE49-F238E27FC236}">
                <a16:creationId xmlns:a16="http://schemas.microsoft.com/office/drawing/2014/main" id="{B9D8B7F2-5240-4A92-8B43-540A5374BCE0}"/>
              </a:ext>
            </a:extLst>
          </p:cNvPr>
          <p:cNvCxnSpPr>
            <a:cxnSpLocks/>
          </p:cNvCxnSpPr>
          <p:nvPr/>
        </p:nvCxnSpPr>
        <p:spPr>
          <a:xfrm>
            <a:off x="3501008" y="755576"/>
            <a:ext cx="100811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5" name="Gerade Verbindung mit Pfeil 72">
            <a:extLst>
              <a:ext uri="{FF2B5EF4-FFF2-40B4-BE49-F238E27FC236}">
                <a16:creationId xmlns:a16="http://schemas.microsoft.com/office/drawing/2014/main" id="{6CD67773-9F35-4A41-A655-63B6F272460D}"/>
              </a:ext>
            </a:extLst>
          </p:cNvPr>
          <p:cNvCxnSpPr>
            <a:cxnSpLocks/>
          </p:cNvCxnSpPr>
          <p:nvPr/>
        </p:nvCxnSpPr>
        <p:spPr>
          <a:xfrm flipH="1">
            <a:off x="3248980" y="1043608"/>
            <a:ext cx="36004" cy="113064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pic>
        <p:nvPicPr>
          <p:cNvPr id="26" name="Picture 2">
            <a:extLst>
              <a:ext uri="{FF2B5EF4-FFF2-40B4-BE49-F238E27FC236}">
                <a16:creationId xmlns:a16="http://schemas.microsoft.com/office/drawing/2014/main" id="{2C663BBA-F915-4D3A-A50A-285C8B48597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59" t="2400" b="8800"/>
          <a:stretch/>
        </p:blipFill>
        <p:spPr bwMode="auto">
          <a:xfrm>
            <a:off x="1003102" y="4283969"/>
            <a:ext cx="1488990" cy="14401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3">
            <a:extLst>
              <a:ext uri="{FF2B5EF4-FFF2-40B4-BE49-F238E27FC236}">
                <a16:creationId xmlns:a16="http://schemas.microsoft.com/office/drawing/2014/main" id="{8EB563B8-4CCB-45EA-9531-828C9E0F315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12" t="1739" b="7063"/>
          <a:stretch/>
        </p:blipFill>
        <p:spPr bwMode="auto">
          <a:xfrm>
            <a:off x="2924944" y="4283968"/>
            <a:ext cx="1452950" cy="14790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" name="Picture 4">
            <a:extLst>
              <a:ext uri="{FF2B5EF4-FFF2-40B4-BE49-F238E27FC236}">
                <a16:creationId xmlns:a16="http://schemas.microsoft.com/office/drawing/2014/main" id="{4ADDEA1A-430B-486D-8936-BEB35066721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25" t="2400" b="6400"/>
          <a:stretch/>
        </p:blipFill>
        <p:spPr bwMode="auto">
          <a:xfrm>
            <a:off x="4869160" y="4283969"/>
            <a:ext cx="1488990" cy="14790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10">
            <a:extLst>
              <a:ext uri="{FF2B5EF4-FFF2-40B4-BE49-F238E27FC236}">
                <a16:creationId xmlns:a16="http://schemas.microsoft.com/office/drawing/2014/main" id="{317737BE-BC49-4B87-87F3-21A7E6CF48F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12" t="2400" b="8800"/>
          <a:stretch/>
        </p:blipFill>
        <p:spPr bwMode="auto">
          <a:xfrm>
            <a:off x="4797152" y="6228184"/>
            <a:ext cx="1452951" cy="14401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Gerade Verbindung mit Pfeil 82">
            <a:extLst>
              <a:ext uri="{FF2B5EF4-FFF2-40B4-BE49-F238E27FC236}">
                <a16:creationId xmlns:a16="http://schemas.microsoft.com/office/drawing/2014/main" id="{05930B75-6FE1-4D23-B0B5-F114FE9F6F1C}"/>
              </a:ext>
            </a:extLst>
          </p:cNvPr>
          <p:cNvCxnSpPr/>
          <p:nvPr/>
        </p:nvCxnSpPr>
        <p:spPr>
          <a:xfrm>
            <a:off x="1412776" y="5854377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Gerade Verbindung mit Pfeil 82">
            <a:extLst>
              <a:ext uri="{FF2B5EF4-FFF2-40B4-BE49-F238E27FC236}">
                <a16:creationId xmlns:a16="http://schemas.microsoft.com/office/drawing/2014/main" id="{EE77FE47-65A9-4C4A-BB05-5E758F411B11}"/>
              </a:ext>
            </a:extLst>
          </p:cNvPr>
          <p:cNvCxnSpPr/>
          <p:nvPr/>
        </p:nvCxnSpPr>
        <p:spPr>
          <a:xfrm>
            <a:off x="3356992" y="5854377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Gerade Verbindung mit Pfeil 82">
            <a:extLst>
              <a:ext uri="{FF2B5EF4-FFF2-40B4-BE49-F238E27FC236}">
                <a16:creationId xmlns:a16="http://schemas.microsoft.com/office/drawing/2014/main" id="{9B338C96-CC31-494C-87A9-5F58773BB9E0}"/>
              </a:ext>
            </a:extLst>
          </p:cNvPr>
          <p:cNvCxnSpPr/>
          <p:nvPr/>
        </p:nvCxnSpPr>
        <p:spPr>
          <a:xfrm>
            <a:off x="5229200" y="5854377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Gerade Verbindung mit Pfeil 82">
            <a:extLst>
              <a:ext uri="{FF2B5EF4-FFF2-40B4-BE49-F238E27FC236}">
                <a16:creationId xmlns:a16="http://schemas.microsoft.com/office/drawing/2014/main" id="{0699DF40-1E12-4D2C-844B-17A51004E87B}"/>
              </a:ext>
            </a:extLst>
          </p:cNvPr>
          <p:cNvCxnSpPr/>
          <p:nvPr/>
        </p:nvCxnSpPr>
        <p:spPr>
          <a:xfrm>
            <a:off x="5157192" y="7812360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feld 60">
            <a:extLst>
              <a:ext uri="{FF2B5EF4-FFF2-40B4-BE49-F238E27FC236}">
                <a16:creationId xmlns:a16="http://schemas.microsoft.com/office/drawing/2014/main" id="{4B969AB4-7F54-4957-B6E6-C7CE027B8A97}"/>
              </a:ext>
            </a:extLst>
          </p:cNvPr>
          <p:cNvSpPr txBox="1"/>
          <p:nvPr/>
        </p:nvSpPr>
        <p:spPr>
          <a:xfrm>
            <a:off x="957064" y="5854377"/>
            <a:ext cx="5352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FSC                       muCD45                    CD19</a:t>
            </a:r>
          </a:p>
        </p:txBody>
      </p:sp>
      <p:sp>
        <p:nvSpPr>
          <p:cNvPr id="35" name="Textfeld 61">
            <a:extLst>
              <a:ext uri="{FF2B5EF4-FFF2-40B4-BE49-F238E27FC236}">
                <a16:creationId xmlns:a16="http://schemas.microsoft.com/office/drawing/2014/main" id="{70FB3B80-45ED-424B-8FA7-65B99D4DD516}"/>
              </a:ext>
            </a:extLst>
          </p:cNvPr>
          <p:cNvSpPr txBox="1"/>
          <p:nvPr/>
        </p:nvSpPr>
        <p:spPr>
          <a:xfrm>
            <a:off x="4437112" y="7812360"/>
            <a:ext cx="16566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FSC             </a:t>
            </a:r>
          </a:p>
        </p:txBody>
      </p:sp>
      <p:cxnSp>
        <p:nvCxnSpPr>
          <p:cNvPr id="36" name="Gerade Verbindung mit Pfeil 82">
            <a:extLst>
              <a:ext uri="{FF2B5EF4-FFF2-40B4-BE49-F238E27FC236}">
                <a16:creationId xmlns:a16="http://schemas.microsoft.com/office/drawing/2014/main" id="{B78E6082-957E-44B5-9792-0020CE635F3E}"/>
              </a:ext>
            </a:extLst>
          </p:cNvPr>
          <p:cNvCxnSpPr>
            <a:cxnSpLocks/>
          </p:cNvCxnSpPr>
          <p:nvPr/>
        </p:nvCxnSpPr>
        <p:spPr>
          <a:xfrm rot="16200000">
            <a:off x="548680" y="4990281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Gerade Verbindung mit Pfeil 82">
            <a:extLst>
              <a:ext uri="{FF2B5EF4-FFF2-40B4-BE49-F238E27FC236}">
                <a16:creationId xmlns:a16="http://schemas.microsoft.com/office/drawing/2014/main" id="{67BFA08C-DAF9-47FB-B74B-5E53F0170FF4}"/>
              </a:ext>
            </a:extLst>
          </p:cNvPr>
          <p:cNvCxnSpPr>
            <a:cxnSpLocks/>
          </p:cNvCxnSpPr>
          <p:nvPr/>
        </p:nvCxnSpPr>
        <p:spPr>
          <a:xfrm rot="16200000">
            <a:off x="2492896" y="4990281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Gerade Verbindung mit Pfeil 82">
            <a:extLst>
              <a:ext uri="{FF2B5EF4-FFF2-40B4-BE49-F238E27FC236}">
                <a16:creationId xmlns:a16="http://schemas.microsoft.com/office/drawing/2014/main" id="{672894F6-A960-4961-9C62-A512FE304A6A}"/>
              </a:ext>
            </a:extLst>
          </p:cNvPr>
          <p:cNvCxnSpPr>
            <a:cxnSpLocks/>
          </p:cNvCxnSpPr>
          <p:nvPr/>
        </p:nvCxnSpPr>
        <p:spPr>
          <a:xfrm rot="16200000">
            <a:off x="4437112" y="4990282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Gerade Verbindung mit Pfeil 82">
            <a:extLst>
              <a:ext uri="{FF2B5EF4-FFF2-40B4-BE49-F238E27FC236}">
                <a16:creationId xmlns:a16="http://schemas.microsoft.com/office/drawing/2014/main" id="{20C89D3D-423B-45A8-9285-0F35289F0BFE}"/>
              </a:ext>
            </a:extLst>
          </p:cNvPr>
          <p:cNvCxnSpPr>
            <a:cxnSpLocks/>
          </p:cNvCxnSpPr>
          <p:nvPr/>
        </p:nvCxnSpPr>
        <p:spPr>
          <a:xfrm rot="16200000">
            <a:off x="4365104" y="7020272"/>
            <a:ext cx="72008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feld 67">
            <a:extLst>
              <a:ext uri="{FF2B5EF4-FFF2-40B4-BE49-F238E27FC236}">
                <a16:creationId xmlns:a16="http://schemas.microsoft.com/office/drawing/2014/main" id="{F8162381-5092-4CED-9329-4DFD23334A25}"/>
              </a:ext>
            </a:extLst>
          </p:cNvPr>
          <p:cNvSpPr txBox="1"/>
          <p:nvPr/>
        </p:nvSpPr>
        <p:spPr>
          <a:xfrm>
            <a:off x="476672" y="4478674"/>
            <a:ext cx="430887" cy="10156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67">
            <a:extLst>
              <a:ext uri="{FF2B5EF4-FFF2-40B4-BE49-F238E27FC236}">
                <a16:creationId xmlns:a16="http://schemas.microsoft.com/office/drawing/2014/main" id="{CA190EC9-970C-4DDE-950F-5AF87DA9EA92}"/>
              </a:ext>
            </a:extLst>
          </p:cNvPr>
          <p:cNvSpPr txBox="1"/>
          <p:nvPr/>
        </p:nvSpPr>
        <p:spPr>
          <a:xfrm>
            <a:off x="2420888" y="4374714"/>
            <a:ext cx="430887" cy="12636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huCD45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67">
            <a:extLst>
              <a:ext uri="{FF2B5EF4-FFF2-40B4-BE49-F238E27FC236}">
                <a16:creationId xmlns:a16="http://schemas.microsoft.com/office/drawing/2014/main" id="{0B0CC596-3554-4848-9297-9F635CCDB51C}"/>
              </a:ext>
            </a:extLst>
          </p:cNvPr>
          <p:cNvSpPr txBox="1"/>
          <p:nvPr/>
        </p:nvSpPr>
        <p:spPr>
          <a:xfrm>
            <a:off x="4365104" y="4374714"/>
            <a:ext cx="430887" cy="12636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D10</a:t>
            </a:r>
            <a:endParaRPr lang="de-DE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67">
            <a:extLst>
              <a:ext uri="{FF2B5EF4-FFF2-40B4-BE49-F238E27FC236}">
                <a16:creationId xmlns:a16="http://schemas.microsoft.com/office/drawing/2014/main" id="{F567C53C-8D73-4274-B48F-179612764024}"/>
              </a:ext>
            </a:extLst>
          </p:cNvPr>
          <p:cNvSpPr txBox="1"/>
          <p:nvPr/>
        </p:nvSpPr>
        <p:spPr>
          <a:xfrm>
            <a:off x="4293096" y="6444208"/>
            <a:ext cx="430887" cy="126363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44" name="Textfeld 212">
            <a:extLst>
              <a:ext uri="{FF2B5EF4-FFF2-40B4-BE49-F238E27FC236}">
                <a16:creationId xmlns:a16="http://schemas.microsoft.com/office/drawing/2014/main" id="{86EABF41-4A7F-4391-BFE0-3F236425E0E1}"/>
              </a:ext>
            </a:extLst>
          </p:cNvPr>
          <p:cNvSpPr txBox="1"/>
          <p:nvPr/>
        </p:nvSpPr>
        <p:spPr>
          <a:xfrm>
            <a:off x="446475" y="4057492"/>
            <a:ext cx="3902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Gerade Verbindung mit Pfeil 72">
            <a:extLst>
              <a:ext uri="{FF2B5EF4-FFF2-40B4-BE49-F238E27FC236}">
                <a16:creationId xmlns:a16="http://schemas.microsoft.com/office/drawing/2014/main" id="{23162F5E-A35E-44BA-975D-BDD49B8EC98B}"/>
              </a:ext>
            </a:extLst>
          </p:cNvPr>
          <p:cNvCxnSpPr>
            <a:cxnSpLocks/>
          </p:cNvCxnSpPr>
          <p:nvPr/>
        </p:nvCxnSpPr>
        <p:spPr>
          <a:xfrm>
            <a:off x="1916832" y="4886335"/>
            <a:ext cx="64807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46" name="Gerade Verbindung mit Pfeil 72">
            <a:extLst>
              <a:ext uri="{FF2B5EF4-FFF2-40B4-BE49-F238E27FC236}">
                <a16:creationId xmlns:a16="http://schemas.microsoft.com/office/drawing/2014/main" id="{D890A258-478A-44BC-B664-5EEEEC68F4FB}"/>
              </a:ext>
            </a:extLst>
          </p:cNvPr>
          <p:cNvCxnSpPr>
            <a:cxnSpLocks/>
          </p:cNvCxnSpPr>
          <p:nvPr/>
        </p:nvCxnSpPr>
        <p:spPr>
          <a:xfrm>
            <a:off x="3429000" y="4742319"/>
            <a:ext cx="1008112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47" name="Gerade Verbindung mit Pfeil 72">
            <a:extLst>
              <a:ext uri="{FF2B5EF4-FFF2-40B4-BE49-F238E27FC236}">
                <a16:creationId xmlns:a16="http://schemas.microsoft.com/office/drawing/2014/main" id="{1AEEC88F-4A51-4845-85A3-D0AB8A1F0A7A}"/>
              </a:ext>
            </a:extLst>
          </p:cNvPr>
          <p:cNvCxnSpPr>
            <a:cxnSpLocks/>
          </p:cNvCxnSpPr>
          <p:nvPr/>
        </p:nvCxnSpPr>
        <p:spPr>
          <a:xfrm>
            <a:off x="6093296" y="4814327"/>
            <a:ext cx="0" cy="136815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48" name="Rechteck 47"/>
          <p:cNvSpPr/>
          <p:nvPr/>
        </p:nvSpPr>
        <p:spPr>
          <a:xfrm>
            <a:off x="130324" y="8100392"/>
            <a:ext cx="6727676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l figure 7: Xenotransplantation assay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Lentivirally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transduced or untransduced human HSPC were 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i.v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injected in </a:t>
            </a:r>
            <a:r>
              <a:rPr lang="en-US" sz="1000" i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ag2</a:t>
            </a:r>
            <a:r>
              <a:rPr lang="en-US" sz="1000" i="1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−/−</a:t>
            </a:r>
            <a:r>
              <a:rPr lang="en-US" sz="1000" i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γc</a:t>
            </a:r>
            <a:r>
              <a:rPr lang="en-US" sz="1000" i="1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−/−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mice after sub-lethal irradiation. Mice were sacrificed 7-8 weeks after transplantation and bone marrow (BM) and spleen were analyzed by flow cytometry.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A)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ACS plots show gating strategy for human CD45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, CD34</a:t>
            </a:r>
            <a:r>
              <a:rPr lang="en-US" sz="1000" baseline="30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+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and myeloid cells.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B)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FACS plots show gating strategy for human B cells based on expression of CD19, CD10 and IgM.</a:t>
            </a:r>
            <a:endParaRPr lang="de-DE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743475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7</Words>
  <Application>Microsoft Office PowerPoint</Application>
  <PresentationFormat>Bildschirmpräsentation (4:3)</PresentationFormat>
  <Paragraphs>135</Paragraphs>
  <Slides>1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3</vt:i4>
      </vt:variant>
    </vt:vector>
  </HeadingPairs>
  <TitlesOfParts>
    <vt:vector size="17" baseType="lpstr">
      <vt:lpstr>Arial</vt:lpstr>
      <vt:lpstr>Calibri</vt:lpstr>
      <vt:lpstr>Verdana</vt:lpstr>
      <vt:lpstr>Larissa-Desig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ehar Afreen</dc:creator>
  <cp:lastModifiedBy>Miriam Erlacher</cp:lastModifiedBy>
  <cp:revision>35</cp:revision>
  <cp:lastPrinted>2019-08-19T13:54:07Z</cp:lastPrinted>
  <dcterms:created xsi:type="dcterms:W3CDTF">2018-12-03T17:12:48Z</dcterms:created>
  <dcterms:modified xsi:type="dcterms:W3CDTF">2019-11-16T13:53:18Z</dcterms:modified>
</cp:coreProperties>
</file>